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58" r:id="rId4"/>
    <p:sldId id="260" r:id="rId5"/>
    <p:sldId id="261" r:id="rId6"/>
    <p:sldId id="262" r:id="rId7"/>
    <p:sldId id="263" r:id="rId8"/>
    <p:sldId id="264" r:id="rId9"/>
    <p:sldId id="265" r:id="rId10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2286" y="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1464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E4A70-6123-4BC8-AA67-7661DCB519F9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2205F-F869-49C5-8E48-4FD216351C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65893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E4A70-6123-4BC8-AA67-7661DCB519F9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2205F-F869-49C5-8E48-4FD216351C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62279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E4A70-6123-4BC8-AA67-7661DCB519F9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2205F-F869-49C5-8E48-4FD216351C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12734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E4A70-6123-4BC8-AA67-7661DCB519F9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2205F-F869-49C5-8E48-4FD216351C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66515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E4A70-6123-4BC8-AA67-7661DCB519F9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2205F-F869-49C5-8E48-4FD216351C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3745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E4A70-6123-4BC8-AA67-7661DCB519F9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2205F-F869-49C5-8E48-4FD216351C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89312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E4A70-6123-4BC8-AA67-7661DCB519F9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2205F-F869-49C5-8E48-4FD216351C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5736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E4A70-6123-4BC8-AA67-7661DCB519F9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2205F-F869-49C5-8E48-4FD216351C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97683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E4A70-6123-4BC8-AA67-7661DCB519F9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2205F-F869-49C5-8E48-4FD216351C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2329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E4A70-6123-4BC8-AA67-7661DCB519F9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2205F-F869-49C5-8E48-4FD216351C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81362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E4A70-6123-4BC8-AA67-7661DCB519F9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2205F-F869-49C5-8E48-4FD216351C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2256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DE4A70-6123-4BC8-AA67-7661DCB519F9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32205F-F869-49C5-8E48-4FD216351C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674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987"/>
          <a:stretch/>
        </p:blipFill>
        <p:spPr>
          <a:xfrm>
            <a:off x="998009" y="304800"/>
            <a:ext cx="4564591" cy="86106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5410200" y="8534400"/>
            <a:ext cx="93807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S2A Fig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21973098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111"/>
          <a:stretch/>
        </p:blipFill>
        <p:spPr>
          <a:xfrm>
            <a:off x="554592" y="304800"/>
            <a:ext cx="5846208" cy="842965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410200" y="8534400"/>
            <a:ext cx="9284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S2B </a:t>
            </a:r>
            <a:r>
              <a:rPr lang="en-US" sz="2000" dirty="0"/>
              <a:t>Fig</a:t>
            </a:r>
          </a:p>
        </p:txBody>
      </p:sp>
    </p:spTree>
    <p:extLst>
      <p:ext uri="{BB962C8B-B14F-4D97-AF65-F5344CB8AC3E}">
        <p14:creationId xmlns:p14="http://schemas.microsoft.com/office/powerpoint/2010/main" val="2307347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506" y="2019426"/>
            <a:ext cx="6566094" cy="534266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410200" y="8534400"/>
            <a:ext cx="93807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S2C </a:t>
            </a:r>
            <a:r>
              <a:rPr lang="en-US" sz="2000" dirty="0"/>
              <a:t>Fig</a:t>
            </a:r>
          </a:p>
        </p:txBody>
      </p:sp>
    </p:spTree>
    <p:extLst>
      <p:ext uri="{BB962C8B-B14F-4D97-AF65-F5344CB8AC3E}">
        <p14:creationId xmlns:p14="http://schemas.microsoft.com/office/powerpoint/2010/main" val="30795098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" r="59250"/>
          <a:stretch/>
        </p:blipFill>
        <p:spPr>
          <a:xfrm>
            <a:off x="304799" y="1519632"/>
            <a:ext cx="6282133" cy="5719368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410200" y="8534400"/>
            <a:ext cx="93807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S2D </a:t>
            </a:r>
            <a:r>
              <a:rPr lang="en-US" sz="2000" dirty="0"/>
              <a:t>Fig</a:t>
            </a:r>
          </a:p>
        </p:txBody>
      </p:sp>
    </p:spTree>
    <p:extLst>
      <p:ext uri="{BB962C8B-B14F-4D97-AF65-F5344CB8AC3E}">
        <p14:creationId xmlns:p14="http://schemas.microsoft.com/office/powerpoint/2010/main" val="6556720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3333"/>
          <a:stretch/>
        </p:blipFill>
        <p:spPr>
          <a:xfrm>
            <a:off x="239529" y="668836"/>
            <a:ext cx="6389871" cy="6417763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410200" y="8534400"/>
            <a:ext cx="93807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S2E </a:t>
            </a:r>
            <a:r>
              <a:rPr lang="en-US" sz="2000" dirty="0"/>
              <a:t>Fig</a:t>
            </a:r>
          </a:p>
        </p:txBody>
      </p:sp>
    </p:spTree>
    <p:extLst>
      <p:ext uri="{BB962C8B-B14F-4D97-AF65-F5344CB8AC3E}">
        <p14:creationId xmlns:p14="http://schemas.microsoft.com/office/powerpoint/2010/main" val="54700075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140" y="1326775"/>
            <a:ext cx="6548460" cy="6812467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410200" y="8534400"/>
            <a:ext cx="93807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S2F </a:t>
            </a:r>
            <a:r>
              <a:rPr lang="en-US" sz="2000" dirty="0"/>
              <a:t>Fig</a:t>
            </a:r>
          </a:p>
        </p:txBody>
      </p:sp>
    </p:spTree>
    <p:extLst>
      <p:ext uri="{BB962C8B-B14F-4D97-AF65-F5344CB8AC3E}">
        <p14:creationId xmlns:p14="http://schemas.microsoft.com/office/powerpoint/2010/main" val="271300714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5238"/>
          <a:stretch/>
        </p:blipFill>
        <p:spPr>
          <a:xfrm>
            <a:off x="113858" y="1727647"/>
            <a:ext cx="6591742" cy="5739953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410200" y="8534400"/>
            <a:ext cx="95090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S2G </a:t>
            </a:r>
            <a:r>
              <a:rPr lang="en-US" sz="2000" dirty="0"/>
              <a:t>Fig</a:t>
            </a:r>
          </a:p>
        </p:txBody>
      </p:sp>
    </p:spTree>
    <p:extLst>
      <p:ext uri="{BB962C8B-B14F-4D97-AF65-F5344CB8AC3E}">
        <p14:creationId xmlns:p14="http://schemas.microsoft.com/office/powerpoint/2010/main" val="43682101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617" y="1447800"/>
            <a:ext cx="6653183" cy="644686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410200" y="8534400"/>
            <a:ext cx="9492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S2H </a:t>
            </a:r>
            <a:r>
              <a:rPr lang="en-US" sz="2000" dirty="0"/>
              <a:t>Fig</a:t>
            </a:r>
          </a:p>
        </p:txBody>
      </p:sp>
    </p:spTree>
    <p:extLst>
      <p:ext uri="{BB962C8B-B14F-4D97-AF65-F5344CB8AC3E}">
        <p14:creationId xmlns:p14="http://schemas.microsoft.com/office/powerpoint/2010/main" val="3653545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7483"/>
          <a:stretch/>
        </p:blipFill>
        <p:spPr>
          <a:xfrm>
            <a:off x="990600" y="228600"/>
            <a:ext cx="4953000" cy="8129391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410200" y="8534400"/>
            <a:ext cx="85311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smtClean="0"/>
              <a:t>S2I </a:t>
            </a:r>
            <a:r>
              <a:rPr lang="en-US" sz="2000" dirty="0"/>
              <a:t>Fig</a:t>
            </a:r>
          </a:p>
        </p:txBody>
      </p:sp>
    </p:spTree>
    <p:extLst>
      <p:ext uri="{BB962C8B-B14F-4D97-AF65-F5344CB8AC3E}">
        <p14:creationId xmlns:p14="http://schemas.microsoft.com/office/powerpoint/2010/main" val="21704508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18</Words>
  <Application>Microsoft Office PowerPoint</Application>
  <PresentationFormat>On-screen Show (4:3)</PresentationFormat>
  <Paragraphs>9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2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T Southwestern Medical Cen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uth Levitz</dc:creator>
  <cp:lastModifiedBy>Jeffrey Kahn</cp:lastModifiedBy>
  <cp:revision>7</cp:revision>
  <dcterms:created xsi:type="dcterms:W3CDTF">2017-07-26T22:07:52Z</dcterms:created>
  <dcterms:modified xsi:type="dcterms:W3CDTF">2017-07-28T19:47:28Z</dcterms:modified>
</cp:coreProperties>
</file>